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99CC"/>
    <a:srgbClr val="0066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254" autoAdjust="0"/>
    <p:restoredTop sz="94660"/>
  </p:normalViewPr>
  <p:slideViewPr>
    <p:cSldViewPr>
      <p:cViewPr varScale="1">
        <p:scale>
          <a:sx n="68" d="100"/>
          <a:sy n="68" d="100"/>
        </p:scale>
        <p:origin x="-691" y="-6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3055F-F09D-4387-9E12-C424DCBEC423}" type="datetimeFigureOut">
              <a:rPr lang="en-US" smtClean="0"/>
              <a:t>10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8802D-50EC-4CE0-876A-44E8258EBB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62805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3055F-F09D-4387-9E12-C424DCBEC423}" type="datetimeFigureOut">
              <a:rPr lang="en-US" smtClean="0"/>
              <a:t>10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8802D-50EC-4CE0-876A-44E8258EBB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79148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3055F-F09D-4387-9E12-C424DCBEC423}" type="datetimeFigureOut">
              <a:rPr lang="en-US" smtClean="0"/>
              <a:t>10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8802D-50EC-4CE0-876A-44E8258EBB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0942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3055F-F09D-4387-9E12-C424DCBEC423}" type="datetimeFigureOut">
              <a:rPr lang="en-US" smtClean="0"/>
              <a:t>10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8802D-50EC-4CE0-876A-44E8258EBB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21562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3055F-F09D-4387-9E12-C424DCBEC423}" type="datetimeFigureOut">
              <a:rPr lang="en-US" smtClean="0"/>
              <a:t>10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8802D-50EC-4CE0-876A-44E8258EBB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57703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3055F-F09D-4387-9E12-C424DCBEC423}" type="datetimeFigureOut">
              <a:rPr lang="en-US" smtClean="0"/>
              <a:t>10/28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8802D-50EC-4CE0-876A-44E8258EBB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99470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3055F-F09D-4387-9E12-C424DCBEC423}" type="datetimeFigureOut">
              <a:rPr lang="en-US" smtClean="0"/>
              <a:t>10/28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8802D-50EC-4CE0-876A-44E8258EBB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55522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3055F-F09D-4387-9E12-C424DCBEC423}" type="datetimeFigureOut">
              <a:rPr lang="en-US" smtClean="0"/>
              <a:t>10/28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8802D-50EC-4CE0-876A-44E8258EBB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0185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3055F-F09D-4387-9E12-C424DCBEC423}" type="datetimeFigureOut">
              <a:rPr lang="en-US" smtClean="0"/>
              <a:t>10/28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8802D-50EC-4CE0-876A-44E8258EBB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54286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3055F-F09D-4387-9E12-C424DCBEC423}" type="datetimeFigureOut">
              <a:rPr lang="en-US" smtClean="0"/>
              <a:t>10/28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8802D-50EC-4CE0-876A-44E8258EBB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36394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3055F-F09D-4387-9E12-C424DCBEC423}" type="datetimeFigureOut">
              <a:rPr lang="en-US" smtClean="0"/>
              <a:t>10/28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8802D-50EC-4CE0-876A-44E8258EBB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46566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23055F-F09D-4387-9E12-C424DCBEC423}" type="datetimeFigureOut">
              <a:rPr lang="en-US" smtClean="0"/>
              <a:t>10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88802D-50EC-4CE0-876A-44E8258EBB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30587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528" y="0"/>
            <a:ext cx="8388424" cy="6165304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0" y="6054387"/>
            <a:ext cx="91440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Fig. S1 Diagram of experimental details as they occurred over the course of the two experiments from 0 to 50 days after sowing (18). Plants were grown in Yoshida nutrient solution in individual containers under two P treatments: low-P and a +P control. Nutrients (except P) were supplied as ‘shots’ to containers as indicated by light blue ovals. Boxes around nutrient solution activities indicate entire solutions were replaced. P additions are indicated by dark rectangles (low-P) or unfilled rectangles (+P). </a:t>
            </a:r>
          </a:p>
        </p:txBody>
      </p:sp>
    </p:spTree>
    <p:extLst>
      <p:ext uri="{BB962C8B-B14F-4D97-AF65-F5344CB8AC3E}">
        <p14:creationId xmlns:p14="http://schemas.microsoft.com/office/powerpoint/2010/main" val="20681056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9</TotalTime>
  <Words>96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oshib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hias</dc:creator>
  <cp:lastModifiedBy>Matthias</cp:lastModifiedBy>
  <cp:revision>17</cp:revision>
  <cp:lastPrinted>2013-07-05T03:01:11Z</cp:lastPrinted>
  <dcterms:created xsi:type="dcterms:W3CDTF">2013-07-05T01:53:06Z</dcterms:created>
  <dcterms:modified xsi:type="dcterms:W3CDTF">2013-10-28T14:06:10Z</dcterms:modified>
</cp:coreProperties>
</file>